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63"/>
  </p:normalViewPr>
  <p:slideViewPr>
    <p:cSldViewPr snapToGrid="0" snapToObjects="1">
      <p:cViewPr varScale="1">
        <p:scale>
          <a:sx n="97" d="100"/>
          <a:sy n="97" d="100"/>
        </p:scale>
        <p:origin x="2776" y="216"/>
      </p:cViewPr>
      <p:guideLst>
        <p:guide orient="horz" pos="2592"/>
        <p:guide pos="20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0ADA89-858A-F041-A6D6-62EF413A356F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5500" y="685800"/>
            <a:ext cx="2667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5E196F-6131-6B4E-871F-69ADB7166C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608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2556511"/>
            <a:ext cx="5440680" cy="1764030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4663440"/>
            <a:ext cx="448056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593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463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48184" y="396240"/>
            <a:ext cx="1007903" cy="8425816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4472" y="396240"/>
            <a:ext cx="2917032" cy="8425816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567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655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8281"/>
            <a:ext cx="544068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056"/>
            <a:ext cx="544068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271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4473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93620" y="2305050"/>
            <a:ext cx="1962468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789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136"/>
            <a:ext cx="2828132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09850"/>
            <a:ext cx="2828132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842136"/>
            <a:ext cx="2829243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2609850"/>
            <a:ext cx="2829243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837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058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549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7660"/>
            <a:ext cx="2105819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327660"/>
            <a:ext cx="3578225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22120"/>
            <a:ext cx="2105819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804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5760720"/>
            <a:ext cx="384048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735330"/>
            <a:ext cx="384048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6440806"/>
            <a:ext cx="384048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259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566"/>
            <a:ext cx="576072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240"/>
            <a:ext cx="576072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81B474-F371-9F4F-8C3B-C89EEBEF3B52}" type="datetimeFigureOut">
              <a:rPr lang="en-US" smtClean="0"/>
              <a:t>1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7627621"/>
            <a:ext cx="20269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7621"/>
            <a:ext cx="149352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EB65D-3BEE-1743-8CC1-E67D0FAF9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571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1501" y="173907"/>
            <a:ext cx="5107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855636" y="247902"/>
            <a:ext cx="1558846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lay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54024" y="218636"/>
            <a:ext cx="1102798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45038" y="530346"/>
            <a:ext cx="1828800" cy="13716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1924" y="530346"/>
            <a:ext cx="1828800" cy="13716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4146" y="530346"/>
            <a:ext cx="1828800" cy="13716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927648" y="232493"/>
            <a:ext cx="1102798" cy="23446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3651" y="1972491"/>
            <a:ext cx="1828800" cy="13716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1924" y="1972491"/>
            <a:ext cx="1828800" cy="13716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45038" y="1972491"/>
            <a:ext cx="1828800" cy="13716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45038" y="3398255"/>
            <a:ext cx="1828800" cy="13716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4146" y="3419245"/>
            <a:ext cx="1828800" cy="13716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71924" y="3419245"/>
            <a:ext cx="1828800" cy="13716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45038" y="4869791"/>
            <a:ext cx="1828800" cy="13716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371924" y="4869791"/>
            <a:ext cx="1828800" cy="13716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4146" y="4869791"/>
            <a:ext cx="1828800" cy="137160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106340" y="6599190"/>
            <a:ext cx="60658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</a:t>
            </a:r>
            <a:r>
              <a:rPr lang="en-US" sz="1200" b="1">
                <a:latin typeface="Times New Roman"/>
                <a:cs typeface="Times New Roman"/>
              </a:rPr>
              <a:t>Figure </a:t>
            </a:r>
            <a:r>
              <a:rPr lang="en-US" sz="1200" b="1" dirty="0">
                <a:latin typeface="Times New Roman"/>
                <a:cs typeface="Times New Roman"/>
              </a:rPr>
              <a:t>9</a:t>
            </a:r>
            <a:r>
              <a:rPr lang="en-US" sz="1200" b="1">
                <a:latin typeface="Times New Roman"/>
                <a:cs typeface="Times New Roman"/>
              </a:rPr>
              <a:t>.</a:t>
            </a:r>
            <a:r>
              <a:rPr lang="en-US" sz="120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Saline- or morphine-treated intestinal organoids were established and cultured for five days. The organoids were fixed and stained with  anti-Ki67 antibody and DAPI.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42504" y="6252975"/>
            <a:ext cx="1914318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sz="1100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-67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1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69488" y="906426"/>
            <a:ext cx="798085" cy="219079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</a:p>
        </p:txBody>
      </p:sp>
      <p:sp>
        <p:nvSpPr>
          <p:cNvPr id="27" name="TextBox 26"/>
          <p:cNvSpPr txBox="1"/>
          <p:nvPr/>
        </p:nvSpPr>
        <p:spPr>
          <a:xfrm rot="16200000">
            <a:off x="-179257" y="2427160"/>
            <a:ext cx="1026236" cy="227688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ine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-172546" y="3666625"/>
            <a:ext cx="981611" cy="219079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ne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262179" y="5087539"/>
            <a:ext cx="1177810" cy="219079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ine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-289637" y="1450336"/>
            <a:ext cx="798085" cy="219079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-281701" y="4430670"/>
            <a:ext cx="798085" cy="219079"/>
          </a:xfrm>
          <a:prstGeom prst="rect">
            <a:avLst/>
          </a:prstGeom>
          <a:noFill/>
        </p:spPr>
        <p:txBody>
          <a:bodyPr wrap="square" lIns="79800" tIns="39900" rIns="79800" bIns="39900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26</a:t>
            </a:r>
          </a:p>
        </p:txBody>
      </p:sp>
      <p:cxnSp>
        <p:nvCxnSpPr>
          <p:cNvPr id="32" name="Straight Connector 31"/>
          <p:cNvCxnSpPr/>
          <p:nvPr/>
        </p:nvCxnSpPr>
        <p:spPr>
          <a:xfrm>
            <a:off x="236380" y="1006008"/>
            <a:ext cx="0" cy="1828798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236380" y="3904659"/>
            <a:ext cx="0" cy="182880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0130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2</TotalTime>
  <Words>43</Words>
  <Application>Microsoft Macintosh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44</cp:revision>
  <dcterms:created xsi:type="dcterms:W3CDTF">2017-05-03T17:28:48Z</dcterms:created>
  <dcterms:modified xsi:type="dcterms:W3CDTF">2019-12-19T06:27:38Z</dcterms:modified>
</cp:coreProperties>
</file>